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B4E8ED-1ACB-47FD-A7A1-8C924EC1F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69B243-D057-410F-BE3E-C921B70503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CD084-6802-4FBE-A4F3-B9DCD5D10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D8BC1E-80A0-4FE4-93D1-EDF943572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9B5FCA-4829-40CF-AEA0-70CF45F02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47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AA29D4-DFE1-4EE5-9FA4-33D98AFF10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6800A8-28C5-4DD3-9CBF-518E341E9E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AB5C5D-9CFE-4428-94CE-DC889073E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A1C345-9E98-499E-8BA9-4D6DE921A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672768-CDE2-4AEF-8D39-FDF0A9C6A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502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1AB8FF-3B7B-4F36-9ADB-1C71B6EFD1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EA4F2D-A461-4449-897C-D9EC8D04ED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2CDE37-CD05-461C-A175-071176673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552B9E-6238-47D7-B75A-A11359663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743E15-3AA5-48B4-A54B-63256B3ED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241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F749E2-14CE-4559-8C26-D2372E4CA1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C18C6F-106D-47CC-8EF1-D4EADB7552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A37947-A676-465F-A979-1C2032C8E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28133F-F43D-4EDE-9D9B-AC5D75ED2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758EE2-47E7-4EA3-B875-462EF97B5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702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F2AB6-83B8-4DE6-9DAA-6A42FDF211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0B0B6C-4819-479C-8CC7-37B3C374D4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D068CB-66C9-45CD-B21D-4EFA33619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364DC6-6A11-4588-BC8D-EFC1815CA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DB9016-0DA5-4BF5-AADF-1A94701F5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031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779D32-C514-4419-A5B6-EED383A665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E0F9B5-509E-4EA8-9C06-ECC0C94649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8663A8-FDEB-45C3-9EE0-15B2F3D725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B778D3-EA30-4592-9A8F-D840AFC25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681378-C164-4BDD-ACF0-D99226CD8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F064AE-D169-4D01-87B7-9CF5FF1E3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650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64BB8D-1F04-4DCC-B02A-44B2A5D99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9A65C5-85CA-477C-8A4F-F5D40F5107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F2F104-5173-49DE-BD71-4A6F911B3C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2D5E00-FA18-4E29-88A2-00E60B5AC2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03863F-F65C-4987-9F11-2222187534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8ED8EF-4189-499D-9BBF-93C03598C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2DF40FD-B0CA-4CAA-887C-11E17CD7AE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855A31-7906-4016-898A-05E37B8D2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053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DADE6-B2E3-427F-973F-03ED7AAE03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61AF0C-FFCA-4C55-B83D-6A263BC29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5C57C6-BBE2-4E19-8D22-04D6080D5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BAF3C2-4DC0-4132-A48A-498A42E14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779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305E67-AA00-4E8F-AFEF-1D63B6362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044CC9-8272-448F-8F84-DE317475A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737EB7-75FC-44BD-80B5-D163A90EA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237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741296-45E1-4CCA-A67A-90469EAB5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BC9214-059A-428C-BE88-7C3A941329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ADA12D-E224-47AD-B5D5-1DC2491C7A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92D3BC-1705-45E6-A2AE-ADCA03C1F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4EF281-98FF-42C8-8D41-F3E8857EF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236F1E-CD5D-4158-9951-AB02AC0AC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315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FAEC8-A428-4804-8A1F-411EC7766B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642487-69BA-40C5-9530-1DE4A638E6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C32005-3987-4590-87DC-27AB27760C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EE47B4-489D-44AF-853E-29A49CD496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7FFACC-75FF-4108-9A2C-CB69469FB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9C4244-63E9-4AB6-B0DE-5150D50D4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357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DE953D-F526-439A-8ECA-3EC1108EB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223376-F5E2-47FF-A555-86142B352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AB54BC-7E2B-405F-B58A-81B5E8CF49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341484-8756-4476-92CB-38AAB3C0AB0F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1AC731-F971-48BA-ABA2-C49F1EF6D4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50DC2F-5304-460D-A29E-FE5BD9FC2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166591-BF49-4CAA-A8BD-77CE46637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227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8DC544F-3023-4AF5-8469-817D83CEEA72}"/>
              </a:ext>
            </a:extLst>
          </p:cNvPr>
          <p:cNvSpPr txBox="1"/>
          <p:nvPr/>
        </p:nvSpPr>
        <p:spPr>
          <a:xfrm>
            <a:off x="1723024" y="874222"/>
            <a:ext cx="903733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: Manuscript ID: ijms-1737937. Effects of miRNA-149-5p and Platelet-Activating Fac-tor-Receptor Signaling on the Growth and Targeted Therapy Response on Lung Cancer Cells.</a:t>
            </a:r>
            <a:endParaRPr lang="en-US" dirty="0"/>
          </a:p>
          <a:p>
            <a:r>
              <a:rPr lang="en-US" dirty="0"/>
              <a:t> </a:t>
            </a:r>
          </a:p>
        </p:txBody>
      </p:sp>
      <p:pic>
        <p:nvPicPr>
          <p:cNvPr id="7" name="Picture 6" descr="Text, letter&#10;&#10;Description automatically generated">
            <a:extLst>
              <a:ext uri="{FF2B5EF4-FFF2-40B4-BE49-F238E27FC236}">
                <a16:creationId xmlns:a16="http://schemas.microsoft.com/office/drawing/2014/main" id="{7EC4BB81-9E4E-4121-8EF6-70ECED73D1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6987" y="2205037"/>
            <a:ext cx="7058025" cy="2447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2705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2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hu, Ravi P</dc:creator>
  <cp:lastModifiedBy>MDPI</cp:lastModifiedBy>
  <cp:revision>17</cp:revision>
  <dcterms:created xsi:type="dcterms:W3CDTF">2022-05-19T18:58:31Z</dcterms:created>
  <dcterms:modified xsi:type="dcterms:W3CDTF">2022-06-21T02:18:05Z</dcterms:modified>
</cp:coreProperties>
</file>